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94"/>
    <p:restoredTop sz="94604"/>
  </p:normalViewPr>
  <p:slideViewPr>
    <p:cSldViewPr snapToGrid="0" snapToObjects="1">
      <p:cViewPr varScale="1">
        <p:scale>
          <a:sx n="90" d="100"/>
          <a:sy n="90" d="100"/>
        </p:scale>
        <p:origin x="3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E8FC84-B889-F14B-AFE1-95D05BC567E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A1CFE97-8AF6-7140-ACD7-4062F3BBB8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84C90F-0B1A-0C40-8F68-83B14571BE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EF2F4-154D-CB48-AB16-9DE6EF19E9EF}" type="datetimeFigureOut">
              <a:rPr lang="de-DE" smtClean="0"/>
              <a:t>03.10.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841886-2CC3-0341-9CC1-923D92B7FF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2AC557-76AC-0341-BCBA-BD90F58B41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BEF94-EEAE-6E44-9289-38EB00B3AE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9110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70073B-652C-8949-9750-C4683E1875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81907B-D436-1647-B040-A8FC2D8222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9E7EF7-7B5F-704F-A039-443A999EC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EF2F4-154D-CB48-AB16-9DE6EF19E9EF}" type="datetimeFigureOut">
              <a:rPr lang="de-DE" smtClean="0"/>
              <a:t>03.10.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473C92-45FF-BB43-A5CD-29CDCE88B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DC50BC-A75A-CA4C-8C60-68C354F346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BEF94-EEAE-6E44-9289-38EB00B3AE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7602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74E1CC0-1BA1-384F-9ED3-BD15C16643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83D3993-EC5F-1847-9B4B-35100E14F5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08836B-1E3D-3C49-AFE5-1B5DB5ED33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EF2F4-154D-CB48-AB16-9DE6EF19E9EF}" type="datetimeFigureOut">
              <a:rPr lang="de-DE" smtClean="0"/>
              <a:t>03.10.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CC7EFE-1F7D-D241-B0BF-5CA17ECCB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DFA6F8-7BAD-CC42-B2C9-1285F1C74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BEF94-EEAE-6E44-9289-38EB00B3AE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33637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67234C-8B37-AA4A-B0C1-5E4FEE9936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9207F3-0D06-DC46-819F-2976415050A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209D88-B742-0145-B62B-519E2C2294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EF2F4-154D-CB48-AB16-9DE6EF19E9EF}" type="datetimeFigureOut">
              <a:rPr lang="de-DE" smtClean="0"/>
              <a:t>03.10.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3975B0-DD3E-3E4D-80BF-562576466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76D20C-9C59-1147-B701-6AD5591D9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BEF94-EEAE-6E44-9289-38EB00B3AE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74551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FC8539-A4C5-934C-931A-B8CFCC882F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0162F8-8004-6D44-85CC-89E5538BB9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081049-DFF0-C54C-870D-425A2F3899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EF2F4-154D-CB48-AB16-9DE6EF19E9EF}" type="datetimeFigureOut">
              <a:rPr lang="de-DE" smtClean="0"/>
              <a:t>03.10.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DA85A0-AACA-A74B-B6A4-8966F4F4FF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3276BF-F104-BA4D-B973-55C92907C9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BEF94-EEAE-6E44-9289-38EB00B3AE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4698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655719-A7A8-6142-9047-EAA54382D7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F16C0C-FE8F-D64E-A3D5-DD30747EED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DD8B36-4604-0A49-B15E-06D2EDE818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4DAB2F-CEB6-604B-8E00-B41EB49018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EF2F4-154D-CB48-AB16-9DE6EF19E9EF}" type="datetimeFigureOut">
              <a:rPr lang="de-DE" smtClean="0"/>
              <a:t>03.10.20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F51058-0873-7245-8704-5B6581EB50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68C07F-D75A-A740-AFF7-CB49F8A07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BEF94-EEAE-6E44-9289-38EB00B3AE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881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F90B75-55AC-6E4D-A135-6B32813E9B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BA0DF8-7206-9D4D-8860-DBEB67B3A4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AB682C-1638-B942-BF6A-966F42D4D7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D995B2D-F02A-B94A-B0A4-AD05AAFC74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A9FAFD-A10A-1641-AB6D-6DE9E308AD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140588D-BC81-CF4A-8D10-EA3F87F492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EF2F4-154D-CB48-AB16-9DE6EF19E9EF}" type="datetimeFigureOut">
              <a:rPr lang="de-DE" smtClean="0"/>
              <a:t>03.10.20</a:t>
            </a:fld>
            <a:endParaRPr lang="de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3F6E782-FC2C-B14D-B208-165388893F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6792E9D-5161-C94E-A21F-FC0C2B9CA0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BEF94-EEAE-6E44-9289-38EB00B3AE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42476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4A87A1-AE98-6444-A283-FA2E2B26BE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32EE80-DF0D-F143-A560-E160E02653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EF2F4-154D-CB48-AB16-9DE6EF19E9EF}" type="datetimeFigureOut">
              <a:rPr lang="de-DE" smtClean="0"/>
              <a:t>03.10.20</a:t>
            </a:fld>
            <a:endParaRPr lang="de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7E305E5-B463-0B48-B39E-1ABBC77808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FF2500F-FB37-214B-963A-A90FB46D73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BEF94-EEAE-6E44-9289-38EB00B3AE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93234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A84D89E-B8C9-1040-AD06-D80A04FD31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EF2F4-154D-CB48-AB16-9DE6EF19E9EF}" type="datetimeFigureOut">
              <a:rPr lang="de-DE" smtClean="0"/>
              <a:t>03.10.20</a:t>
            </a:fld>
            <a:endParaRPr lang="de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2463BFB-58BD-CC4A-A06D-76B3BDF1C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D917771-99D4-A946-AEA9-86CE98E84E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BEF94-EEAE-6E44-9289-38EB00B3AE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22368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D01F32-57CE-1B44-809E-C0AF213024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6D0EC6-8F68-9244-8D3A-3F2D14AE47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9DD379-669B-B84D-91F2-78BB480D98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33172F-90A5-5741-9547-503360406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EF2F4-154D-CB48-AB16-9DE6EF19E9EF}" type="datetimeFigureOut">
              <a:rPr lang="de-DE" smtClean="0"/>
              <a:t>03.10.20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36D76B-E7E8-144C-833A-F589FD3236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B2FE6D-2878-2A4F-B492-7B8520C59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BEF94-EEAE-6E44-9289-38EB00B3AE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5825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0D58B3-EB75-C449-9FAF-1B1EE70357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ED8467A-0234-F942-895B-D612D3FC3E7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556241-A583-4A4C-8DA6-7C11502EA3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1787DE-E3E0-1043-9720-1225D0672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EF2F4-154D-CB48-AB16-9DE6EF19E9EF}" type="datetimeFigureOut">
              <a:rPr lang="de-DE" smtClean="0"/>
              <a:t>03.10.20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3218C6-6B29-3944-8C81-BE061817E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2BA226-C2ED-994F-ACF1-1F94EFBF00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BEF94-EEAE-6E44-9289-38EB00B3AE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3736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8DA88D8-2A73-7846-B1A0-8E921F579E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030F17-5D7E-5049-91BB-38E7F34E42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0C28C9-18E2-6D44-9C91-D635C38937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4EF2F4-154D-CB48-AB16-9DE6EF19E9EF}" type="datetimeFigureOut">
              <a:rPr lang="de-DE" smtClean="0"/>
              <a:t>03.10.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A73C65-D015-FD46-9C2F-02176E20B1B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475949-EBE5-5B40-88D2-10B1665D7D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3BEF94-EEAE-6E44-9289-38EB00B3AE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8357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20" descr="Ein Bild, das Screenshot enthält.&#10;&#10;Automatisch generierte Beschreibung">
            <a:extLst>
              <a:ext uri="{FF2B5EF4-FFF2-40B4-BE49-F238E27FC236}">
                <a16:creationId xmlns:a16="http://schemas.microsoft.com/office/drawing/2014/main" id="{CBB8E592-BC7D-BE41-8B34-F6A0FFA73AC0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1470" y="347980"/>
            <a:ext cx="6409055" cy="567626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BBD9E515-F532-0841-8952-CF3D13A71E04}"/>
              </a:ext>
            </a:extLst>
          </p:cNvPr>
          <p:cNvSpPr/>
          <p:nvPr/>
        </p:nvSpPr>
        <p:spPr>
          <a:xfrm>
            <a:off x="1109661" y="6218528"/>
            <a:ext cx="9972675" cy="4633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b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figure 2.</a:t>
            </a: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Flowchart illustrating the acquisition of study centers in the PATRONUS study. </a:t>
            </a:r>
            <a:endParaRPr lang="de-DE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90636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 Mihaljevic</dc:creator>
  <cp:lastModifiedBy>Andre Mihaljevic</cp:lastModifiedBy>
  <cp:revision>1</cp:revision>
  <dcterms:created xsi:type="dcterms:W3CDTF">2020-10-03T07:17:01Z</dcterms:created>
  <dcterms:modified xsi:type="dcterms:W3CDTF">2020-10-03T07:17:37Z</dcterms:modified>
</cp:coreProperties>
</file>